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CFBA9-2B2B-4763-8B87-0C1C271E19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575B7-3A02-4110-9CA0-F97681411E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F2139-2E3B-4933-B627-ED8A260669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03A1B-769A-43AE-AD18-96CC521950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5651A-FA91-4A71-9857-27C15F98AA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0ED2C-9554-40FC-8B72-108EC091F6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3E939C-B00E-470C-8A40-0A72E989C1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479A3-FB77-4F53-AD51-4DAC638714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E9326-6555-4166-99AF-FE5146D7B0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B8967-0B44-43C7-8F02-C7FE0FFFA2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24007-BC11-4CB2-9C09-BB83BF4ECC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BA590-8207-481E-BF4B-47029D4453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AF917E-48D7-4FF8-BA51-22424B422BAE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4"/>
          <p:cNvGrpSpPr/>
          <p:nvPr/>
        </p:nvGrpSpPr>
        <p:grpSpPr>
          <a:xfrm>
            <a:off x="2095560" y="1808280"/>
            <a:ext cx="4951440" cy="3240000"/>
            <a:chOff x="2095560" y="1808280"/>
            <a:chExt cx="4951440" cy="3240000"/>
          </a:xfrm>
        </p:grpSpPr>
        <p:pic>
          <p:nvPicPr>
            <p:cNvPr id="42" name="图片 2" descr=""/>
            <p:cNvPicPr/>
            <p:nvPr/>
          </p:nvPicPr>
          <p:blipFill>
            <a:blip r:embed="rId1"/>
            <a:stretch/>
          </p:blipFill>
          <p:spPr>
            <a:xfrm>
              <a:off x="2095560" y="1808280"/>
              <a:ext cx="4951440" cy="32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文本框 3"/>
            <p:cNvSpPr/>
            <p:nvPr/>
          </p:nvSpPr>
          <p:spPr>
            <a:xfrm>
              <a:off x="2999520" y="4658400"/>
              <a:ext cx="40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6HBE       A549       H460        H23        H27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" name="文本框 2"/>
          <p:cNvSpPr/>
          <p:nvPr/>
        </p:nvSpPr>
        <p:spPr>
          <a:xfrm>
            <a:off x="557280" y="5661000"/>
            <a:ext cx="8028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等线"/>
              </a:rPr>
              <a:t>Supplementary figure 1. The let-7c-5p expression in NSCLC cell lines and in normal pulmonary epithelial cell line 16HBE determined by RT-qPCR (**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等线"/>
              </a:rPr>
              <a:t> &lt; 0.01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7-25T10:35:58Z</dcterms:created>
  <dc:creator>Administrator</dc:creator>
  <dc:description/>
  <dc:language>en-US</dc:language>
  <cp:lastModifiedBy>刘金龙</cp:lastModifiedBy>
  <dcterms:modified xsi:type="dcterms:W3CDTF">2025-05-11T08:36:41Z</dcterms:modified>
  <cp:revision>58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0CC5946DCEC441D9000AAA7ED2E9742_12</vt:lpwstr>
  </property>
  <property fmtid="{D5CDD505-2E9C-101B-9397-08002B2CF9AE}" pid="3" name="KSOProductBuildVer">
    <vt:lpwstr>2052-12.1.0.18608</vt:lpwstr>
  </property>
</Properties>
</file>